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C09CD9-736E-4300-B058-E1B33E10EA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3454B3-9C6B-4176-AB55-3D6671E1B2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BC439-9CC3-429E-A4E2-99786A8F34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28F34-B6E5-4E66-9D1F-19F12BF304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9D0FF9-1388-4FB5-87DD-4B70FA7BE3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EF262F-471D-4295-ABF9-337C31615C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9F1710-4B6B-4241-B663-0349A76813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027D38-18AB-480C-8073-11DFB2E3FC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F4606C-8408-4438-A764-8CA61BF393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4F59C-EBDA-4F5D-9747-FC85B61D95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11A71D-E4DA-4873-9A38-09CE4C8943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33A5D-076D-44D8-8E37-AE31EAEED9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EE5427-7695-4510-81D1-9CBF6F58D56D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77920" y="15778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465120" y="316224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457200" y="6634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514440" y="31780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1154160" y="277020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1295280" y="816120"/>
            <a:ext cx="4550040" cy="436536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669960" y="5751360"/>
            <a:ext cx="588312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5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ucine content along the six LGR protein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amoebophil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50-residue windows sliding by 10-residue steps). The LRR domain is separated of the remaining part of the protein by a dashed line. A strong conservation of the signal can be seen in the non-LRR part of the protein, eg. the two "cat ears" located on the amino acid sequences between positions 900 and 1100. A 28-residue periodicity is observed on these profiles in the LRR domains. No particular enrichment of LRR units in leucine can be shown on this profil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3T09:22:55Z</dcterms:created>
  <dc:creator>Gilbert Greub</dc:creator>
  <dc:description/>
  <dc:language>en-US</dc:language>
  <cp:lastModifiedBy>CA Roten</cp:lastModifiedBy>
  <dcterms:modified xsi:type="dcterms:W3CDTF">2007-11-14T10:47:18Z</dcterms:modified>
  <cp:revision>8</cp:revision>
  <dc:subject/>
  <dc:title>Présentation PowerPoint</dc:title>
</cp:coreProperties>
</file>